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0" r:id="rId2"/>
    <p:sldId id="271" r:id="rId3"/>
    <p:sldId id="268" r:id="rId4"/>
    <p:sldId id="26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20" autoAdjust="0"/>
    <p:restoredTop sz="94631"/>
  </p:normalViewPr>
  <p:slideViewPr>
    <p:cSldViewPr snapToGrid="0" snapToObjects="1">
      <p:cViewPr varScale="1">
        <p:scale>
          <a:sx n="81" d="100"/>
          <a:sy n="81" d="100"/>
        </p:scale>
        <p:origin x="-102" y="-7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igrid.heuer\Desktop\Sigrid\MPI%20Golm%20Pup1\Metabolomics\paper\Phenotypic%20data\metabolomics%20MPI%20phenotypic%20data_%20plants%20at%20maturity_for%20Michael_Sigrid%202015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igrid.heuer\Desktop\Sigrid\MPI%20Golm%20Pup1\Metabolomics\paper\Phenotypic%20data\metabolomics%20MPI%20phenotypic%20data_%20plants%20at%20maturity_for%20Michael_Sigrid%202015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average sigrid 2015 harvest'!$AM$3</c:f>
              <c:strCache>
                <c:ptCount val="1"/>
                <c:pt idx="0">
                  <c:v>Dular</c:v>
                </c:pt>
              </c:strCache>
            </c:strRef>
          </c:tx>
          <c:invertIfNegative val="0"/>
          <c:cat>
            <c:strRef>
              <c:f>'average sigrid 2015 harvest'!$AN$2:$AQ$2</c:f>
              <c:strCache>
                <c:ptCount val="4"/>
                <c:pt idx="0">
                  <c:v>PH</c:v>
                </c:pt>
                <c:pt idx="1">
                  <c:v>TN</c:v>
                </c:pt>
                <c:pt idx="2">
                  <c:v>SW</c:v>
                </c:pt>
                <c:pt idx="3">
                  <c:v>RW</c:v>
                </c:pt>
              </c:strCache>
            </c:strRef>
          </c:cat>
          <c:val>
            <c:numRef>
              <c:f>'average sigrid 2015 harvest'!$AN$3:$AQ$3</c:f>
              <c:numCache>
                <c:formatCode>0.0</c:formatCode>
                <c:ptCount val="4"/>
                <c:pt idx="0">
                  <c:v>0.39797112758486702</c:v>
                </c:pt>
                <c:pt idx="1">
                  <c:v>-20.8955223880597</c:v>
                </c:pt>
                <c:pt idx="2">
                  <c:v>1.711335136464214</c:v>
                </c:pt>
                <c:pt idx="3">
                  <c:v>-18.673179955877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8EB-46DA-ABBF-8A71C94D567C}"/>
            </c:ext>
          </c:extLst>
        </c:ser>
        <c:ser>
          <c:idx val="1"/>
          <c:order val="1"/>
          <c:tx>
            <c:strRef>
              <c:f>'average sigrid 2015 harvest'!$AM$4</c:f>
              <c:strCache>
                <c:ptCount val="1"/>
                <c:pt idx="0">
                  <c:v>N22</c:v>
                </c:pt>
              </c:strCache>
            </c:strRef>
          </c:tx>
          <c:invertIfNegative val="0"/>
          <c:cat>
            <c:strRef>
              <c:f>'average sigrid 2015 harvest'!$AN$2:$AQ$2</c:f>
              <c:strCache>
                <c:ptCount val="4"/>
                <c:pt idx="0">
                  <c:v>PH</c:v>
                </c:pt>
                <c:pt idx="1">
                  <c:v>TN</c:v>
                </c:pt>
                <c:pt idx="2">
                  <c:v>SW</c:v>
                </c:pt>
                <c:pt idx="3">
                  <c:v>RW</c:v>
                </c:pt>
              </c:strCache>
            </c:strRef>
          </c:cat>
          <c:val>
            <c:numRef>
              <c:f>'average sigrid 2015 harvest'!$AN$4:$AQ$4</c:f>
              <c:numCache>
                <c:formatCode>0.0</c:formatCode>
                <c:ptCount val="4"/>
                <c:pt idx="0">
                  <c:v>1.329051824101342</c:v>
                </c:pt>
                <c:pt idx="1">
                  <c:v>-19.512195121951208</c:v>
                </c:pt>
                <c:pt idx="2">
                  <c:v>-7.7011576903717582</c:v>
                </c:pt>
                <c:pt idx="3">
                  <c:v>-22.29809277136801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18EB-46DA-ABBF-8A71C94D567C}"/>
            </c:ext>
          </c:extLst>
        </c:ser>
        <c:ser>
          <c:idx val="2"/>
          <c:order val="2"/>
          <c:tx>
            <c:strRef>
              <c:f>'average sigrid 2015 harvest'!$AM$5</c:f>
              <c:strCache>
                <c:ptCount val="1"/>
                <c:pt idx="0">
                  <c:v>IR64 </c:v>
                </c:pt>
              </c:strCache>
            </c:strRef>
          </c:tx>
          <c:invertIfNegative val="0"/>
          <c:cat>
            <c:strRef>
              <c:f>'average sigrid 2015 harvest'!$AN$2:$AQ$2</c:f>
              <c:strCache>
                <c:ptCount val="4"/>
                <c:pt idx="0">
                  <c:v>PH</c:v>
                </c:pt>
                <c:pt idx="1">
                  <c:v>TN</c:v>
                </c:pt>
                <c:pt idx="2">
                  <c:v>SW</c:v>
                </c:pt>
                <c:pt idx="3">
                  <c:v>RW</c:v>
                </c:pt>
              </c:strCache>
            </c:strRef>
          </c:cat>
          <c:val>
            <c:numRef>
              <c:f>'average sigrid 2015 harvest'!$AN$5:$AQ$5</c:f>
              <c:numCache>
                <c:formatCode>0.0</c:formatCode>
                <c:ptCount val="4"/>
                <c:pt idx="0">
                  <c:v>3.071284125379163</c:v>
                </c:pt>
                <c:pt idx="1">
                  <c:v>-25.409836065573771</c:v>
                </c:pt>
                <c:pt idx="2">
                  <c:v>-25.193264852271529</c:v>
                </c:pt>
                <c:pt idx="3">
                  <c:v>-44.42613948380010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18EB-46DA-ABBF-8A71C94D567C}"/>
            </c:ext>
          </c:extLst>
        </c:ser>
        <c:ser>
          <c:idx val="3"/>
          <c:order val="3"/>
          <c:tx>
            <c:strRef>
              <c:f>'average sigrid 2015 harvest'!$AM$6</c:f>
              <c:strCache>
                <c:ptCount val="1"/>
                <c:pt idx="0">
                  <c:v>IR74</c:v>
                </c:pt>
              </c:strCache>
            </c:strRef>
          </c:tx>
          <c:invertIfNegative val="0"/>
          <c:cat>
            <c:strRef>
              <c:f>'average sigrid 2015 harvest'!$AN$2:$AQ$2</c:f>
              <c:strCache>
                <c:ptCount val="4"/>
                <c:pt idx="0">
                  <c:v>PH</c:v>
                </c:pt>
                <c:pt idx="1">
                  <c:v>TN</c:v>
                </c:pt>
                <c:pt idx="2">
                  <c:v>SW</c:v>
                </c:pt>
                <c:pt idx="3">
                  <c:v>RW</c:v>
                </c:pt>
              </c:strCache>
            </c:strRef>
          </c:cat>
          <c:val>
            <c:numRef>
              <c:f>'average sigrid 2015 harvest'!$AN$6:$AQ$6</c:f>
              <c:numCache>
                <c:formatCode>0.0</c:formatCode>
                <c:ptCount val="4"/>
                <c:pt idx="0">
                  <c:v>-5.1199809931099862</c:v>
                </c:pt>
                <c:pt idx="1">
                  <c:v>-20.353982300884951</c:v>
                </c:pt>
                <c:pt idx="2">
                  <c:v>-9.7429577464788633</c:v>
                </c:pt>
                <c:pt idx="3">
                  <c:v>-16.94464944649444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18EB-46DA-ABBF-8A71C94D56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1749504"/>
        <c:axId val="81751040"/>
      </c:barChart>
      <c:catAx>
        <c:axId val="8174950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low"/>
        <c:txPr>
          <a:bodyPr/>
          <a:lstStyle/>
          <a:p>
            <a:pPr>
              <a:defRPr sz="1400"/>
            </a:pPr>
            <a:endParaRPr lang="en-US"/>
          </a:p>
        </c:txPr>
        <c:crossAx val="81751040"/>
        <c:crosses val="autoZero"/>
        <c:auto val="1"/>
        <c:lblAlgn val="ctr"/>
        <c:lblOffset val="100"/>
        <c:noMultiLvlLbl val="0"/>
      </c:catAx>
      <c:valAx>
        <c:axId val="81751040"/>
        <c:scaling>
          <c:orientation val="minMax"/>
        </c:scaling>
        <c:delete val="0"/>
        <c:axPos val="l"/>
        <c:majorGridlines/>
        <c:numFmt formatCode="0" sourceLinked="0"/>
        <c:majorTickMark val="none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81749504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1400"/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average sigrid 2015 harvest'!$L$1</c:f>
              <c:strCache>
                <c:ptCount val="1"/>
                <c:pt idx="0">
                  <c:v>av filled grain 5 pan</c:v>
                </c:pt>
              </c:strCache>
            </c:strRef>
          </c:tx>
          <c:invertIfNegative val="0"/>
          <c:dLbls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200">
                    <a:solidFill>
                      <a:schemeClr val="bg1"/>
                    </a:solidFill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multiLvlStrRef>
              <c:f>'average sigrid 2015 harvest'!$B$2:$C$9</c:f>
              <c:multiLvlStrCache>
                <c:ptCount val="8"/>
                <c:lvl>
                  <c:pt idx="0">
                    <c:v>WW</c:v>
                  </c:pt>
                  <c:pt idx="1">
                    <c:v>D</c:v>
                  </c:pt>
                  <c:pt idx="2">
                    <c:v>WW</c:v>
                  </c:pt>
                  <c:pt idx="3">
                    <c:v>D</c:v>
                  </c:pt>
                  <c:pt idx="4">
                    <c:v>WW</c:v>
                  </c:pt>
                  <c:pt idx="5">
                    <c:v>D</c:v>
                  </c:pt>
                  <c:pt idx="6">
                    <c:v>WW</c:v>
                  </c:pt>
                  <c:pt idx="7">
                    <c:v>D</c:v>
                  </c:pt>
                </c:lvl>
                <c:lvl>
                  <c:pt idx="0">
                    <c:v>Dular</c:v>
                  </c:pt>
                  <c:pt idx="1">
                    <c:v>Dular</c:v>
                  </c:pt>
                  <c:pt idx="2">
                    <c:v>N22 </c:v>
                  </c:pt>
                  <c:pt idx="3">
                    <c:v>N22 </c:v>
                  </c:pt>
                  <c:pt idx="4">
                    <c:v>IR64 </c:v>
                  </c:pt>
                  <c:pt idx="5">
                    <c:v>IR64 </c:v>
                  </c:pt>
                  <c:pt idx="6">
                    <c:v>IR74</c:v>
                  </c:pt>
                  <c:pt idx="7">
                    <c:v>IR74</c:v>
                  </c:pt>
                </c:lvl>
              </c:multiLvlStrCache>
            </c:multiLvlStrRef>
          </c:cat>
          <c:val>
            <c:numRef>
              <c:f>'average sigrid 2015 harvest'!$L$2:$L$9</c:f>
              <c:numCache>
                <c:formatCode>0</c:formatCode>
                <c:ptCount val="8"/>
                <c:pt idx="0">
                  <c:v>112.65</c:v>
                </c:pt>
                <c:pt idx="1">
                  <c:v>101.27500000000001</c:v>
                </c:pt>
                <c:pt idx="2">
                  <c:v>119.75</c:v>
                </c:pt>
                <c:pt idx="3">
                  <c:v>109.425</c:v>
                </c:pt>
                <c:pt idx="4">
                  <c:v>106.55</c:v>
                </c:pt>
                <c:pt idx="5">
                  <c:v>79.525000000000006</c:v>
                </c:pt>
                <c:pt idx="6">
                  <c:v>83.25</c:v>
                </c:pt>
                <c:pt idx="7">
                  <c:v>67.72499999999999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BEC-428A-AFED-389A036CCDC4}"/>
            </c:ext>
          </c:extLst>
        </c:ser>
        <c:ser>
          <c:idx val="1"/>
          <c:order val="1"/>
          <c:tx>
            <c:strRef>
              <c:f>'average sigrid 2015 harvest'!$N$1</c:f>
              <c:strCache>
                <c:ptCount val="1"/>
                <c:pt idx="0">
                  <c:v>av unfilled grain 5 pan</c:v>
                </c:pt>
              </c:strCache>
            </c:strRef>
          </c:tx>
          <c:invertIfNegative val="0"/>
          <c:dLbls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1200">
                    <a:solidFill>
                      <a:schemeClr val="tx1"/>
                    </a:solidFill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multiLvlStrRef>
              <c:f>'average sigrid 2015 harvest'!$B$2:$C$9</c:f>
              <c:multiLvlStrCache>
                <c:ptCount val="8"/>
                <c:lvl>
                  <c:pt idx="0">
                    <c:v>WW</c:v>
                  </c:pt>
                  <c:pt idx="1">
                    <c:v>D</c:v>
                  </c:pt>
                  <c:pt idx="2">
                    <c:v>WW</c:v>
                  </c:pt>
                  <c:pt idx="3">
                    <c:v>D</c:v>
                  </c:pt>
                  <c:pt idx="4">
                    <c:v>WW</c:v>
                  </c:pt>
                  <c:pt idx="5">
                    <c:v>D</c:v>
                  </c:pt>
                  <c:pt idx="6">
                    <c:v>WW</c:v>
                  </c:pt>
                  <c:pt idx="7">
                    <c:v>D</c:v>
                  </c:pt>
                </c:lvl>
                <c:lvl>
                  <c:pt idx="0">
                    <c:v>Dular</c:v>
                  </c:pt>
                  <c:pt idx="1">
                    <c:v>Dular</c:v>
                  </c:pt>
                  <c:pt idx="2">
                    <c:v>N22 </c:v>
                  </c:pt>
                  <c:pt idx="3">
                    <c:v>N22 </c:v>
                  </c:pt>
                  <c:pt idx="4">
                    <c:v>IR64 </c:v>
                  </c:pt>
                  <c:pt idx="5">
                    <c:v>IR64 </c:v>
                  </c:pt>
                  <c:pt idx="6">
                    <c:v>IR74</c:v>
                  </c:pt>
                  <c:pt idx="7">
                    <c:v>IR74</c:v>
                  </c:pt>
                </c:lvl>
              </c:multiLvlStrCache>
            </c:multiLvlStrRef>
          </c:cat>
          <c:val>
            <c:numRef>
              <c:f>'average sigrid 2015 harvest'!$N$2:$N$9</c:f>
              <c:numCache>
                <c:formatCode>0</c:formatCode>
                <c:ptCount val="8"/>
                <c:pt idx="0">
                  <c:v>29.9</c:v>
                </c:pt>
                <c:pt idx="1">
                  <c:v>62.575000000000003</c:v>
                </c:pt>
                <c:pt idx="2">
                  <c:v>13.875</c:v>
                </c:pt>
                <c:pt idx="3">
                  <c:v>20.75</c:v>
                </c:pt>
                <c:pt idx="4">
                  <c:v>28.225000000000001</c:v>
                </c:pt>
                <c:pt idx="5">
                  <c:v>25.1</c:v>
                </c:pt>
                <c:pt idx="6">
                  <c:v>33.950000000000003</c:v>
                </c:pt>
                <c:pt idx="7">
                  <c:v>32.6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FBEC-428A-AFED-389A036CCD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100"/>
        <c:axId val="101517568"/>
        <c:axId val="101535744"/>
      </c:barChart>
      <c:catAx>
        <c:axId val="10151756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1100"/>
            </a:pPr>
            <a:endParaRPr lang="en-US"/>
          </a:p>
        </c:txPr>
        <c:crossAx val="101535744"/>
        <c:crosses val="autoZero"/>
        <c:auto val="1"/>
        <c:lblAlgn val="ctr"/>
        <c:lblOffset val="50"/>
        <c:noMultiLvlLbl val="1"/>
      </c:catAx>
      <c:valAx>
        <c:axId val="101535744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0" sourceLinked="0"/>
        <c:majorTickMark val="out"/>
        <c:minorTickMark val="none"/>
        <c:tickLblPos val="nextTo"/>
        <c:crossAx val="101517568"/>
        <c:crosses val="autoZero"/>
        <c:crossBetween val="between"/>
      </c:valAx>
      <c:spPr>
        <a:noFill/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8A08F-467D-CA4A-B67F-684EC17F99A7}" type="datetimeFigureOut">
              <a:rPr lang="en-US" smtClean="0"/>
              <a:t>11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1661A-A135-4B4D-801E-61C7A65FE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3225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8A08F-467D-CA4A-B67F-684EC17F99A7}" type="datetimeFigureOut">
              <a:rPr lang="en-US" smtClean="0"/>
              <a:t>11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1661A-A135-4B4D-801E-61C7A65FE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5036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8A08F-467D-CA4A-B67F-684EC17F99A7}" type="datetimeFigureOut">
              <a:rPr lang="en-US" smtClean="0"/>
              <a:t>11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1661A-A135-4B4D-801E-61C7A65FE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11189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8A08F-467D-CA4A-B67F-684EC17F99A7}" type="datetimeFigureOut">
              <a:rPr lang="en-US" smtClean="0"/>
              <a:t>11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1661A-A135-4B4D-801E-61C7A65FE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0537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8A08F-467D-CA4A-B67F-684EC17F99A7}" type="datetimeFigureOut">
              <a:rPr lang="en-US" smtClean="0"/>
              <a:t>11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1661A-A135-4B4D-801E-61C7A65FE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1758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8A08F-467D-CA4A-B67F-684EC17F99A7}" type="datetimeFigureOut">
              <a:rPr lang="en-US" smtClean="0"/>
              <a:t>11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1661A-A135-4B4D-801E-61C7A65FE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08649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8A08F-467D-CA4A-B67F-684EC17F99A7}" type="datetimeFigureOut">
              <a:rPr lang="en-US" smtClean="0"/>
              <a:t>11/2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1661A-A135-4B4D-801E-61C7A65FE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91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8A08F-467D-CA4A-B67F-684EC17F99A7}" type="datetimeFigureOut">
              <a:rPr lang="en-US" smtClean="0"/>
              <a:t>11/2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1661A-A135-4B4D-801E-61C7A65FE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3416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8A08F-467D-CA4A-B67F-684EC17F99A7}" type="datetimeFigureOut">
              <a:rPr lang="en-US" smtClean="0"/>
              <a:t>11/2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1661A-A135-4B4D-801E-61C7A65FE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4885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8A08F-467D-CA4A-B67F-684EC17F99A7}" type="datetimeFigureOut">
              <a:rPr lang="en-US" smtClean="0"/>
              <a:t>11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1661A-A135-4B4D-801E-61C7A65FE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12036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88A08F-467D-CA4A-B67F-684EC17F99A7}" type="datetimeFigureOut">
              <a:rPr lang="en-US" smtClean="0"/>
              <a:t>11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C1661A-A135-4B4D-801E-61C7A65FE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0418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88A08F-467D-CA4A-B67F-684EC17F99A7}" type="datetimeFigureOut">
              <a:rPr lang="en-US" smtClean="0"/>
              <a:t>11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C1661A-A135-4B4D-801E-61C7A65FE8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5467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/>
          <p:cNvGrpSpPr/>
          <p:nvPr/>
        </p:nvGrpSpPr>
        <p:grpSpPr>
          <a:xfrm>
            <a:off x="3346450" y="1196753"/>
            <a:ext cx="5616624" cy="2952327"/>
            <a:chOff x="1822450" y="1196752"/>
            <a:chExt cx="5616624" cy="2952327"/>
          </a:xfrm>
        </p:grpSpPr>
        <p:graphicFrame>
          <p:nvGraphicFramePr>
            <p:cNvPr id="2" name="Chart 1"/>
            <p:cNvGraphicFramePr>
              <a:graphicFrameLocks/>
            </p:cNvGraphicFramePr>
            <p:nvPr>
              <p:extLst/>
            </p:nvPr>
          </p:nvGraphicFramePr>
          <p:xfrm>
            <a:off x="1822450" y="1196752"/>
            <a:ext cx="5616624" cy="295232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7" name="TextBox 6"/>
            <p:cNvSpPr txBox="1"/>
            <p:nvPr/>
          </p:nvSpPr>
          <p:spPr>
            <a:xfrm>
              <a:off x="3791443" y="2748109"/>
              <a:ext cx="38664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/>
                <a:t>***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902753" y="1975777"/>
              <a:ext cx="38664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/>
                <a:t>***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671936" y="2541879"/>
              <a:ext cx="25199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/>
                <a:t>*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988080" y="2578263"/>
              <a:ext cx="38664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/>
                <a:t>***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356592" y="2588462"/>
              <a:ext cx="38664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/>
                <a:t>***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918709" y="2732330"/>
              <a:ext cx="25199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/>
                <a:t>*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6156176" y="2414921"/>
              <a:ext cx="30809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/>
                <a:t>ns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923076" y="3501008"/>
              <a:ext cx="38664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/>
                <a:t>***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759332" y="2631098"/>
              <a:ext cx="32748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/>
                <a:t>**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553986" y="2482841"/>
              <a:ext cx="32748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050" dirty="0"/>
                <a:t>**</a:t>
              </a:r>
            </a:p>
          </p:txBody>
        </p:sp>
      </p:grpSp>
      <p:sp>
        <p:nvSpPr>
          <p:cNvPr id="24" name="TextBox 23"/>
          <p:cNvSpPr txBox="1"/>
          <p:nvPr/>
        </p:nvSpPr>
        <p:spPr>
          <a:xfrm rot="16200000">
            <a:off x="1771949" y="2261033"/>
            <a:ext cx="284122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/>
              <a:t>% change under drought versus WW</a:t>
            </a:r>
          </a:p>
        </p:txBody>
      </p:sp>
      <p:sp>
        <p:nvSpPr>
          <p:cNvPr id="5" name="Rectangle 4"/>
          <p:cNvSpPr/>
          <p:nvPr/>
        </p:nvSpPr>
        <p:spPr>
          <a:xfrm>
            <a:off x="2706163" y="4504467"/>
            <a:ext cx="665951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sz="1200" b="1" dirty="0" smtClean="0"/>
              <a:t>Figure S1</a:t>
            </a:r>
            <a:r>
              <a:rPr lang="en-AU" sz="1200" dirty="0"/>
              <a:t>. Phenotypic data at plant maturity after drought stress.  </a:t>
            </a:r>
            <a:endParaRPr lang="en-GB" sz="1200" dirty="0"/>
          </a:p>
          <a:p>
            <a:pPr algn="just"/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ur rice genotypes representing stress-tolerant </a:t>
            </a:r>
            <a:r>
              <a:rPr lang="en-AU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us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type varieties (</a:t>
            </a:r>
            <a:r>
              <a:rPr lang="en-AU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ular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N22) and intolerant </a:t>
            </a:r>
            <a:r>
              <a:rPr lang="en-AU" sz="12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dica</a:t>
            </a:r>
            <a:r>
              <a:rPr lang="en-AU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type irrigated rice varieties (IR64, IR74) were grown in soil-filled pots under well-watered and dry-down conditions. The percent change of the phenotypic data in plants exposed to the dry-down treatment relative to well-watered control plants is shown. PH= plant height; TN= tiller number; SW= shoot dry weight; RW= root dry weight. Asterisks indicate significant differences of a given variety between WW and dry-down conditions: *= p&lt;0.05; **= p&lt;0.01; ***= p&lt;0.005; ns= not significant.</a:t>
            </a:r>
            <a:endParaRPr lang="en-GB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0655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/>
          </p:nvPr>
        </p:nvGraphicFramePr>
        <p:xfrm>
          <a:off x="2764831" y="1025062"/>
          <a:ext cx="6526796" cy="311769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/>
          <p:cNvSpPr txBox="1"/>
          <p:nvPr/>
        </p:nvSpPr>
        <p:spPr>
          <a:xfrm rot="16200000">
            <a:off x="983227" y="2228417"/>
            <a:ext cx="32626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/>
              <a:t>Filled &amp; unfilled spikelet number panicle-1</a:t>
            </a:r>
          </a:p>
        </p:txBody>
      </p:sp>
      <p:grpSp>
        <p:nvGrpSpPr>
          <p:cNvPr id="32" name="Group 31"/>
          <p:cNvGrpSpPr/>
          <p:nvPr/>
        </p:nvGrpSpPr>
        <p:grpSpPr>
          <a:xfrm>
            <a:off x="2423592" y="4047006"/>
            <a:ext cx="7441982" cy="503760"/>
            <a:chOff x="896923" y="1536466"/>
            <a:chExt cx="7441982" cy="503760"/>
          </a:xfrm>
        </p:grpSpPr>
        <p:sp>
          <p:nvSpPr>
            <p:cNvPr id="10" name="TextBox 9"/>
            <p:cNvSpPr txBox="1"/>
            <p:nvPr/>
          </p:nvSpPr>
          <p:spPr>
            <a:xfrm>
              <a:off x="1764080" y="1628800"/>
              <a:ext cx="458780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solidFill>
                    <a:schemeClr val="tx2">
                      <a:lumMod val="60000"/>
                      <a:lumOff val="40000"/>
                    </a:schemeClr>
                  </a:solidFill>
                </a:rPr>
                <a:t>79.0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483768" y="1628800"/>
              <a:ext cx="458780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solidFill>
                    <a:schemeClr val="tx2">
                      <a:lumMod val="60000"/>
                      <a:lumOff val="40000"/>
                    </a:schemeClr>
                  </a:solidFill>
                </a:rPr>
                <a:t>61.8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276248" y="1628800"/>
              <a:ext cx="458780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solidFill>
                    <a:schemeClr val="tx2">
                      <a:lumMod val="60000"/>
                      <a:lumOff val="40000"/>
                    </a:schemeClr>
                  </a:solidFill>
                </a:rPr>
                <a:t>89.6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995936" y="1628800"/>
              <a:ext cx="458780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solidFill>
                    <a:schemeClr val="tx2">
                      <a:lumMod val="60000"/>
                      <a:lumOff val="40000"/>
                    </a:schemeClr>
                  </a:solidFill>
                </a:rPr>
                <a:t>84.1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746851" y="1628800"/>
              <a:ext cx="458780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solidFill>
                    <a:schemeClr val="tx2">
                      <a:lumMod val="60000"/>
                      <a:lumOff val="40000"/>
                    </a:schemeClr>
                  </a:solidFill>
                </a:rPr>
                <a:t>79.1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521959" y="1628800"/>
              <a:ext cx="458780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solidFill>
                    <a:schemeClr val="tx2">
                      <a:lumMod val="60000"/>
                      <a:lumOff val="40000"/>
                    </a:schemeClr>
                  </a:solidFill>
                </a:rPr>
                <a:t>76.0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242039" y="1628800"/>
              <a:ext cx="458780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solidFill>
                    <a:schemeClr val="tx2">
                      <a:lumMod val="60000"/>
                      <a:lumOff val="40000"/>
                    </a:schemeClr>
                  </a:solidFill>
                </a:rPr>
                <a:t>71.0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7006809" y="1628800"/>
              <a:ext cx="458780" cy="276999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solidFill>
                    <a:schemeClr val="tx2">
                      <a:lumMod val="60000"/>
                      <a:lumOff val="40000"/>
                    </a:schemeClr>
                  </a:solidFill>
                </a:rPr>
                <a:t>67.5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7465589" y="1536466"/>
              <a:ext cx="873316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AU" sz="1200" dirty="0">
                  <a:solidFill>
                    <a:schemeClr val="tx2">
                      <a:lumMod val="60000"/>
                      <a:lumOff val="40000"/>
                    </a:schemeClr>
                  </a:solidFill>
                </a:rPr>
                <a:t>spikelet </a:t>
              </a:r>
            </a:p>
            <a:p>
              <a:r>
                <a:rPr lang="en-AU" sz="1200" dirty="0">
                  <a:solidFill>
                    <a:schemeClr val="tx2">
                      <a:lumMod val="60000"/>
                      <a:lumOff val="40000"/>
                    </a:schemeClr>
                  </a:solidFill>
                </a:rPr>
                <a:t>fertility (%)</a:t>
              </a:r>
            </a:p>
          </p:txBody>
        </p:sp>
        <p:sp>
          <p:nvSpPr>
            <p:cNvPr id="21" name="Rectangle 20"/>
            <p:cNvSpPr/>
            <p:nvPr/>
          </p:nvSpPr>
          <p:spPr>
            <a:xfrm>
              <a:off x="896923" y="1628800"/>
              <a:ext cx="6620583" cy="411426"/>
            </a:xfrm>
            <a:prstGeom prst="rect">
              <a:avLst/>
            </a:prstGeom>
            <a:noFill/>
            <a:ln w="12700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600" dirty="0">
                <a:solidFill>
                  <a:schemeClr val="tx2">
                    <a:lumMod val="60000"/>
                    <a:lumOff val="40000"/>
                  </a:schemeClr>
                </a:solidFill>
              </a:endParaRPr>
            </a:p>
          </p:txBody>
        </p:sp>
      </p:grpSp>
      <p:grpSp>
        <p:nvGrpSpPr>
          <p:cNvPr id="85" name="Group 84"/>
          <p:cNvGrpSpPr/>
          <p:nvPr/>
        </p:nvGrpSpPr>
        <p:grpSpPr>
          <a:xfrm>
            <a:off x="3269792" y="1131408"/>
            <a:ext cx="5701227" cy="1171137"/>
            <a:chOff x="1751093" y="1823171"/>
            <a:chExt cx="5701227" cy="1171137"/>
          </a:xfrm>
        </p:grpSpPr>
        <p:sp>
          <p:nvSpPr>
            <p:cNvPr id="23" name="TextBox 22"/>
            <p:cNvSpPr txBox="1"/>
            <p:nvPr/>
          </p:nvSpPr>
          <p:spPr>
            <a:xfrm>
              <a:off x="1751093" y="2120250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/>
                <a:t>143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560402" y="1823171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/>
                <a:t>164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311317" y="2255643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/>
                <a:t>134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4039665" y="2315704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/>
                <a:t>130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795775" y="2240803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/>
                <a:t>135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531628" y="2661888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/>
                <a:t>105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6298468" y="2466435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/>
                <a:t>117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7032012" y="2717309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200" dirty="0"/>
                <a:t>101</a:t>
              </a:r>
            </a:p>
          </p:txBody>
        </p:sp>
      </p:grpSp>
      <p:sp>
        <p:nvSpPr>
          <p:cNvPr id="33" name="TextBox 32"/>
          <p:cNvSpPr txBox="1"/>
          <p:nvPr/>
        </p:nvSpPr>
        <p:spPr>
          <a:xfrm>
            <a:off x="8962705" y="3136848"/>
            <a:ext cx="10717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/>
              <a:t>filled spikelets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8962706" y="2382305"/>
            <a:ext cx="12504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/>
              <a:t>unfilled spikelets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8962706" y="2000903"/>
            <a:ext cx="15204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/>
              <a:t>total spikelet number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6698799" y="3005524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/>
              <a:t>***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3697274" y="3005524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/>
              <a:t>ns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5257045" y="3005524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/>
              <a:t>ns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8178930" y="3005524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/>
              <a:t>***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3684574" y="1743834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/>
              <a:t>***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5285518" y="1856817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/>
              <a:t>*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6727344" y="2010705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/>
              <a:t>ns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8250546" y="2277902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/>
              <a:t>ns</a:t>
            </a:r>
          </a:p>
        </p:txBody>
      </p:sp>
      <p:grpSp>
        <p:nvGrpSpPr>
          <p:cNvPr id="57" name="Group 56"/>
          <p:cNvGrpSpPr/>
          <p:nvPr/>
        </p:nvGrpSpPr>
        <p:grpSpPr>
          <a:xfrm>
            <a:off x="3498417" y="949958"/>
            <a:ext cx="741812" cy="478528"/>
            <a:chOff x="1967189" y="1484456"/>
            <a:chExt cx="741812" cy="478528"/>
          </a:xfrm>
        </p:grpSpPr>
        <p:cxnSp>
          <p:nvCxnSpPr>
            <p:cNvPr id="51" name="Straight Connector 50"/>
            <p:cNvCxnSpPr/>
            <p:nvPr/>
          </p:nvCxnSpPr>
          <p:spPr>
            <a:xfrm>
              <a:off x="1967953" y="1484784"/>
              <a:ext cx="73945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/>
            <p:cNvCxnSpPr/>
            <p:nvPr/>
          </p:nvCxnSpPr>
          <p:spPr>
            <a:xfrm>
              <a:off x="2709001" y="1484456"/>
              <a:ext cx="0" cy="19437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/>
            <p:cNvCxnSpPr/>
            <p:nvPr/>
          </p:nvCxnSpPr>
          <p:spPr>
            <a:xfrm flipH="1">
              <a:off x="1967189" y="1484456"/>
              <a:ext cx="4762" cy="47852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1" name="Group 60"/>
          <p:cNvGrpSpPr/>
          <p:nvPr/>
        </p:nvGrpSpPr>
        <p:grpSpPr>
          <a:xfrm>
            <a:off x="5034831" y="1364946"/>
            <a:ext cx="740223" cy="253362"/>
            <a:chOff x="1967189" y="1484456"/>
            <a:chExt cx="740223" cy="253362"/>
          </a:xfrm>
        </p:grpSpPr>
        <p:cxnSp>
          <p:nvCxnSpPr>
            <p:cNvPr id="62" name="Straight Connector 61"/>
            <p:cNvCxnSpPr/>
            <p:nvPr/>
          </p:nvCxnSpPr>
          <p:spPr>
            <a:xfrm>
              <a:off x="1967953" y="1484784"/>
              <a:ext cx="73945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/>
            <p:cNvCxnSpPr/>
            <p:nvPr/>
          </p:nvCxnSpPr>
          <p:spPr>
            <a:xfrm flipH="1">
              <a:off x="2704238" y="1484456"/>
              <a:ext cx="1" cy="25336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/>
            <p:cNvCxnSpPr/>
            <p:nvPr/>
          </p:nvCxnSpPr>
          <p:spPr>
            <a:xfrm flipH="1">
              <a:off x="1967189" y="1484456"/>
              <a:ext cx="4762" cy="21041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6" name="Group 65"/>
          <p:cNvGrpSpPr/>
          <p:nvPr/>
        </p:nvGrpSpPr>
        <p:grpSpPr>
          <a:xfrm>
            <a:off x="6581710" y="1349769"/>
            <a:ext cx="740223" cy="581949"/>
            <a:chOff x="1967189" y="1484456"/>
            <a:chExt cx="740223" cy="581949"/>
          </a:xfrm>
        </p:grpSpPr>
        <p:cxnSp>
          <p:nvCxnSpPr>
            <p:cNvPr id="67" name="Straight Connector 66"/>
            <p:cNvCxnSpPr/>
            <p:nvPr/>
          </p:nvCxnSpPr>
          <p:spPr>
            <a:xfrm>
              <a:off x="1967953" y="1484784"/>
              <a:ext cx="73945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Straight Connector 67"/>
            <p:cNvCxnSpPr/>
            <p:nvPr/>
          </p:nvCxnSpPr>
          <p:spPr>
            <a:xfrm>
              <a:off x="2704238" y="1484456"/>
              <a:ext cx="0" cy="58194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/>
            <p:cNvCxnSpPr/>
            <p:nvPr/>
          </p:nvCxnSpPr>
          <p:spPr>
            <a:xfrm flipH="1">
              <a:off x="1967189" y="1484456"/>
              <a:ext cx="4762" cy="21041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9" name="Group 78"/>
          <p:cNvGrpSpPr/>
          <p:nvPr/>
        </p:nvGrpSpPr>
        <p:grpSpPr>
          <a:xfrm>
            <a:off x="8021157" y="1513100"/>
            <a:ext cx="740223" cy="497604"/>
            <a:chOff x="1967189" y="1484456"/>
            <a:chExt cx="740223" cy="497604"/>
          </a:xfrm>
        </p:grpSpPr>
        <p:cxnSp>
          <p:nvCxnSpPr>
            <p:cNvPr id="80" name="Straight Connector 79"/>
            <p:cNvCxnSpPr/>
            <p:nvPr/>
          </p:nvCxnSpPr>
          <p:spPr>
            <a:xfrm>
              <a:off x="1967953" y="1484784"/>
              <a:ext cx="73945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/>
            <p:cNvCxnSpPr/>
            <p:nvPr/>
          </p:nvCxnSpPr>
          <p:spPr>
            <a:xfrm>
              <a:off x="2704239" y="1484456"/>
              <a:ext cx="3173" cy="49760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Connector 81"/>
            <p:cNvCxnSpPr/>
            <p:nvPr/>
          </p:nvCxnSpPr>
          <p:spPr>
            <a:xfrm flipH="1">
              <a:off x="1967189" y="1484456"/>
              <a:ext cx="4762" cy="21041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6" name="TextBox 95"/>
          <p:cNvSpPr txBox="1"/>
          <p:nvPr/>
        </p:nvSpPr>
        <p:spPr>
          <a:xfrm>
            <a:off x="3655999" y="769604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/>
              <a:t>***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8229946" y="1315800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/>
              <a:t>***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6727344" y="1147200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/>
              <a:t>***</a:t>
            </a:r>
          </a:p>
        </p:txBody>
      </p:sp>
      <p:sp>
        <p:nvSpPr>
          <p:cNvPr id="99" name="TextBox 98"/>
          <p:cNvSpPr txBox="1"/>
          <p:nvPr/>
        </p:nvSpPr>
        <p:spPr>
          <a:xfrm>
            <a:off x="5210176" y="1113724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400" dirty="0"/>
              <a:t>ns</a:t>
            </a:r>
          </a:p>
        </p:txBody>
      </p:sp>
      <p:sp>
        <p:nvSpPr>
          <p:cNvPr id="114" name="Rectangle 113"/>
          <p:cNvSpPr/>
          <p:nvPr/>
        </p:nvSpPr>
        <p:spPr>
          <a:xfrm>
            <a:off x="3269792" y="3889364"/>
            <a:ext cx="5989259" cy="21602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 dirty="0"/>
          </a:p>
        </p:txBody>
      </p:sp>
      <p:grpSp>
        <p:nvGrpSpPr>
          <p:cNvPr id="113" name="Group 112"/>
          <p:cNvGrpSpPr/>
          <p:nvPr/>
        </p:nvGrpSpPr>
        <p:grpSpPr>
          <a:xfrm>
            <a:off x="3354395" y="3941628"/>
            <a:ext cx="5555243" cy="307777"/>
            <a:chOff x="1777560" y="4770318"/>
            <a:chExt cx="5555243" cy="307777"/>
          </a:xfrm>
        </p:grpSpPr>
        <p:grpSp>
          <p:nvGrpSpPr>
            <p:cNvPr id="107" name="Group 106"/>
            <p:cNvGrpSpPr/>
            <p:nvPr/>
          </p:nvGrpSpPr>
          <p:grpSpPr>
            <a:xfrm>
              <a:off x="1777560" y="4797152"/>
              <a:ext cx="5555243" cy="0"/>
              <a:chOff x="1777560" y="4653136"/>
              <a:chExt cx="5555243" cy="0"/>
            </a:xfrm>
          </p:grpSpPr>
          <p:cxnSp>
            <p:nvCxnSpPr>
              <p:cNvPr id="103" name="Straight Connector 102"/>
              <p:cNvCxnSpPr/>
              <p:nvPr/>
            </p:nvCxnSpPr>
            <p:spPr>
              <a:xfrm>
                <a:off x="1777560" y="4653136"/>
                <a:ext cx="97818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Straight Connector 103"/>
              <p:cNvCxnSpPr/>
              <p:nvPr/>
            </p:nvCxnSpPr>
            <p:spPr>
              <a:xfrm>
                <a:off x="4805845" y="4653136"/>
                <a:ext cx="97818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Straight Connector 104"/>
              <p:cNvCxnSpPr/>
              <p:nvPr/>
            </p:nvCxnSpPr>
            <p:spPr>
              <a:xfrm>
                <a:off x="6354618" y="4653136"/>
                <a:ext cx="97818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Straight Connector 105"/>
              <p:cNvCxnSpPr/>
              <p:nvPr/>
            </p:nvCxnSpPr>
            <p:spPr>
              <a:xfrm>
                <a:off x="3326509" y="4653136"/>
                <a:ext cx="97818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8" name="TextBox 107"/>
            <p:cNvSpPr txBox="1"/>
            <p:nvPr/>
          </p:nvSpPr>
          <p:spPr>
            <a:xfrm>
              <a:off x="1993584" y="4770318"/>
              <a:ext cx="5806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 err="1"/>
                <a:t>Dular</a:t>
              </a:r>
              <a:endParaRPr lang="en-AU" sz="1400" dirty="0"/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3596552" y="4770318"/>
              <a:ext cx="48282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400" dirty="0"/>
                <a:t>N22</a:t>
              </a: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5089928" y="4770318"/>
              <a:ext cx="5554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/>
                <a:t>IR64</a:t>
              </a: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6622705" y="4770318"/>
              <a:ext cx="5554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400" dirty="0"/>
                <a:t>IR74</a:t>
              </a:r>
            </a:p>
          </p:txBody>
        </p:sp>
      </p:grpSp>
      <p:sp>
        <p:nvSpPr>
          <p:cNvPr id="3" name="Rectangle 2"/>
          <p:cNvSpPr/>
          <p:nvPr/>
        </p:nvSpPr>
        <p:spPr>
          <a:xfrm>
            <a:off x="2524979" y="4900120"/>
            <a:ext cx="795586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sz="1200" b="1" dirty="0" smtClean="0"/>
              <a:t>Figure S2</a:t>
            </a:r>
            <a:r>
              <a:rPr lang="en-AU" sz="1200" dirty="0"/>
              <a:t>. Grain yield and spikelet fertility of drought tolerant and intolerant rice varieties.</a:t>
            </a:r>
            <a:endParaRPr lang="en-GB" sz="1200" dirty="0"/>
          </a:p>
          <a:p>
            <a:pPr lvl="0" algn="just"/>
            <a:r>
              <a:rPr lang="en-AU" sz="12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ur rice genotypes representing stress-tolerant </a:t>
            </a:r>
            <a:r>
              <a:rPr lang="en-AU" sz="1200" dirty="0" err="1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us</a:t>
            </a:r>
            <a:r>
              <a:rPr lang="en-AU" sz="12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type varieties (</a:t>
            </a:r>
            <a:r>
              <a:rPr lang="en-AU" sz="1200" dirty="0" err="1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ular</a:t>
            </a:r>
            <a:r>
              <a:rPr lang="en-AU" sz="12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N22) and intolerant </a:t>
            </a:r>
            <a:r>
              <a:rPr lang="en-AU" sz="1200" dirty="0" err="1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dica</a:t>
            </a:r>
            <a:r>
              <a:rPr lang="en-AU" sz="1200" dirty="0">
                <a:solidFill>
                  <a:prstClr val="black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type irrigated rice varieties (IR64, IR74) were grown in soil-filled pots under well-watered and dry-down conditions. The percent change of the phenotypic data in plants exposed to the dry-down treatment relative to well-watered control plants is shown. PH= plant height; TN= tiller number; SW= shoot dry weight; RW= root dry weight. Asterisks indicate significant differences of a given variety between WW and dry-down conditions: *= p&lt;0.05; **= p&lt;0.01; ***= p&lt;0.005; ns= not significant.</a:t>
            </a:r>
            <a:endParaRPr lang="en-GB" sz="1100" dirty="0">
              <a:solidFill>
                <a:prstClr val="black"/>
              </a:solidFill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25178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/>
          <p:cNvSpPr txBox="1"/>
          <p:nvPr/>
        </p:nvSpPr>
        <p:spPr>
          <a:xfrm>
            <a:off x="1659129" y="5053932"/>
            <a:ext cx="870407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Figure S3</a:t>
            </a:r>
            <a:r>
              <a:rPr lang="en-US" sz="1200" b="1" dirty="0"/>
              <a:t>. </a:t>
            </a:r>
            <a:r>
              <a:rPr lang="en-GB" sz="1200" dirty="0"/>
              <a:t>Hierarchical cluster analysis of metabolites in shoots. </a:t>
            </a:r>
          </a:p>
          <a:p>
            <a:r>
              <a:rPr lang="en-GB" sz="1200" dirty="0"/>
              <a:t>Four rice genotypes representative of the </a:t>
            </a:r>
            <a:r>
              <a:rPr lang="en-GB" sz="1200" dirty="0" err="1"/>
              <a:t>aus</a:t>
            </a:r>
            <a:r>
              <a:rPr lang="en-GB" sz="1200" dirty="0"/>
              <a:t>-type group (AUS; N22, </a:t>
            </a:r>
            <a:r>
              <a:rPr lang="en-GB" sz="1200" dirty="0" err="1"/>
              <a:t>Dular</a:t>
            </a:r>
            <a:r>
              <a:rPr lang="en-GB" sz="1200" dirty="0"/>
              <a:t>) and modern irrigated varieties (IR; IR64,IR74) were grown under well-watered (WW) conditions or exposed to a dry-down treatment (drought). See main text for details.  </a:t>
            </a:r>
            <a:r>
              <a:rPr lang="en-US" sz="1200" dirty="0"/>
              <a:t> 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1524001" y="919484"/>
            <a:ext cx="8973782" cy="3638711"/>
            <a:chOff x="1524001" y="919484"/>
            <a:chExt cx="8973782" cy="3638711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24001" y="919484"/>
              <a:ext cx="8316416" cy="3638711"/>
            </a:xfrm>
            <a:prstGeom prst="rect">
              <a:avLst/>
            </a:prstGeom>
          </p:spPr>
        </p:pic>
        <p:cxnSp>
          <p:nvCxnSpPr>
            <p:cNvPr id="5" name="Straight Connector 4"/>
            <p:cNvCxnSpPr/>
            <p:nvPr/>
          </p:nvCxnSpPr>
          <p:spPr>
            <a:xfrm>
              <a:off x="10056441" y="2081841"/>
              <a:ext cx="0" cy="78972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Connector 5"/>
            <p:cNvCxnSpPr/>
            <p:nvPr/>
          </p:nvCxnSpPr>
          <p:spPr>
            <a:xfrm>
              <a:off x="10056441" y="2911967"/>
              <a:ext cx="0" cy="1616041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TextBox 6"/>
            <p:cNvSpPr txBox="1"/>
            <p:nvPr/>
          </p:nvSpPr>
          <p:spPr>
            <a:xfrm rot="16200000">
              <a:off x="10015599" y="2292036"/>
              <a:ext cx="5950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WW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9836576" y="3566364"/>
              <a:ext cx="9530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Drought</a:t>
              </a:r>
            </a:p>
          </p:txBody>
        </p:sp>
        <p:cxnSp>
          <p:nvCxnSpPr>
            <p:cNvPr id="9" name="Straight Connector 8"/>
            <p:cNvCxnSpPr/>
            <p:nvPr/>
          </p:nvCxnSpPr>
          <p:spPr>
            <a:xfrm flipH="1">
              <a:off x="9759830" y="2450531"/>
              <a:ext cx="1380" cy="432049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>
              <a:off x="9761210" y="3714640"/>
              <a:ext cx="0" cy="777296"/>
            </a:xfrm>
            <a:prstGeom prst="line">
              <a:avLst/>
            </a:prstGeom>
            <a:ln w="2857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>
              <a:off x="9761210" y="2911967"/>
              <a:ext cx="0" cy="7533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9759830" y="2081841"/>
              <a:ext cx="0" cy="355422"/>
            </a:xfrm>
            <a:prstGeom prst="line">
              <a:avLst/>
            </a:prstGeom>
            <a:ln w="2857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 rot="16200000">
              <a:off x="9756237" y="2490190"/>
              <a:ext cx="3674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IR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9656243" y="2088703"/>
              <a:ext cx="5673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US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9656243" y="3918623"/>
              <a:ext cx="5673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US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9756238" y="3089823"/>
              <a:ext cx="3674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IR</a:t>
              </a:r>
            </a:p>
          </p:txBody>
        </p:sp>
        <p:cxnSp>
          <p:nvCxnSpPr>
            <p:cNvPr id="17" name="Straight Connector 16"/>
            <p:cNvCxnSpPr/>
            <p:nvPr/>
          </p:nvCxnSpPr>
          <p:spPr>
            <a:xfrm>
              <a:off x="1769965" y="2897230"/>
              <a:ext cx="7560049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1772345" y="2432501"/>
              <a:ext cx="755766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1956497" y="3793223"/>
              <a:ext cx="756401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9445952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505290" y="316723"/>
            <a:ext cx="9201102" cy="5216441"/>
            <a:chOff x="1521940" y="404665"/>
            <a:chExt cx="9201102" cy="5216441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21940" y="404665"/>
              <a:ext cx="8534501" cy="5216441"/>
            </a:xfrm>
            <a:prstGeom prst="rect">
              <a:avLst/>
            </a:prstGeom>
          </p:spPr>
        </p:pic>
        <p:cxnSp>
          <p:nvCxnSpPr>
            <p:cNvPr id="7" name="Straight Connector 6"/>
            <p:cNvCxnSpPr/>
            <p:nvPr/>
          </p:nvCxnSpPr>
          <p:spPr>
            <a:xfrm>
              <a:off x="10056440" y="1844824"/>
              <a:ext cx="0" cy="1872208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/>
            <p:cNvCxnSpPr/>
            <p:nvPr/>
          </p:nvCxnSpPr>
          <p:spPr>
            <a:xfrm>
              <a:off x="10056440" y="3748897"/>
              <a:ext cx="0" cy="1872208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 rot="16200000">
              <a:off x="9974763" y="2636655"/>
              <a:ext cx="5950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WW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9795740" y="4500334"/>
              <a:ext cx="95308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Drought</a:t>
              </a:r>
            </a:p>
          </p:txBody>
        </p:sp>
        <p:cxnSp>
          <p:nvCxnSpPr>
            <p:cNvPr id="12" name="Straight Connector 11"/>
            <p:cNvCxnSpPr/>
            <p:nvPr/>
          </p:nvCxnSpPr>
          <p:spPr>
            <a:xfrm>
              <a:off x="9912424" y="1844824"/>
              <a:ext cx="0" cy="108012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>
              <a:off x="9912424" y="3748898"/>
              <a:ext cx="0" cy="936103"/>
            </a:xfrm>
            <a:prstGeom prst="line">
              <a:avLst/>
            </a:prstGeom>
            <a:ln w="2857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9912424" y="4685001"/>
              <a:ext cx="0" cy="936104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9912424" y="2924945"/>
              <a:ext cx="0" cy="823953"/>
            </a:xfrm>
            <a:prstGeom prst="line">
              <a:avLst/>
            </a:prstGeom>
            <a:ln w="2857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/>
            <p:cNvSpPr txBox="1"/>
            <p:nvPr/>
          </p:nvSpPr>
          <p:spPr>
            <a:xfrm rot="16200000">
              <a:off x="10338022" y="2160564"/>
              <a:ext cx="3674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IR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 rot="16200000">
              <a:off x="10246637" y="3133502"/>
              <a:ext cx="5673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US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 rot="16200000">
              <a:off x="10254676" y="4025416"/>
              <a:ext cx="5673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US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 rot="16200000">
              <a:off x="10352734" y="5012214"/>
              <a:ext cx="3674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IR</a:t>
              </a:r>
            </a:p>
          </p:txBody>
        </p:sp>
        <p:sp>
          <p:nvSpPr>
            <p:cNvPr id="33" name="Rectangle 32"/>
            <p:cNvSpPr/>
            <p:nvPr/>
          </p:nvSpPr>
          <p:spPr>
            <a:xfrm>
              <a:off x="9533912" y="2636913"/>
              <a:ext cx="378512" cy="18440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17" name="TextBox 16"/>
          <p:cNvSpPr txBox="1"/>
          <p:nvPr/>
        </p:nvSpPr>
        <p:spPr>
          <a:xfrm>
            <a:off x="1601572" y="5754808"/>
            <a:ext cx="908817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smtClean="0"/>
              <a:t>Figure S4</a:t>
            </a:r>
            <a:r>
              <a:rPr lang="en-US" sz="1200" b="1" dirty="0"/>
              <a:t>. </a:t>
            </a:r>
            <a:r>
              <a:rPr lang="en-GB" sz="1200" dirty="0"/>
              <a:t>Hierarchical cluster analysis of metabolites in r</a:t>
            </a:r>
            <a:r>
              <a:rPr lang="en-US" sz="1200" dirty="0" err="1"/>
              <a:t>oots</a:t>
            </a:r>
            <a:r>
              <a:rPr lang="en-US" sz="1200" dirty="0"/>
              <a:t>.</a:t>
            </a:r>
          </a:p>
          <a:p>
            <a:r>
              <a:rPr lang="en-GB" sz="1200" dirty="0"/>
              <a:t>Four rice genotypes representative of the </a:t>
            </a:r>
            <a:r>
              <a:rPr lang="en-GB" sz="1200" dirty="0" err="1"/>
              <a:t>aus</a:t>
            </a:r>
            <a:r>
              <a:rPr lang="en-GB" sz="1200" dirty="0"/>
              <a:t>-type group (AUS; N22, </a:t>
            </a:r>
            <a:r>
              <a:rPr lang="en-GB" sz="1200" dirty="0" err="1"/>
              <a:t>Dular</a:t>
            </a:r>
            <a:r>
              <a:rPr lang="en-GB" sz="1200" dirty="0"/>
              <a:t>) and modern irrigated varieties (IR; IR64,IR74) were grown under well-watered (WW) conditions or exposed to a dry-down treatment (drought). See main text for details.  </a:t>
            </a:r>
            <a:r>
              <a:rPr lang="en-US" sz="1200" dirty="0"/>
              <a:t>  </a:t>
            </a:r>
          </a:p>
        </p:txBody>
      </p:sp>
    </p:spTree>
    <p:extLst>
      <p:ext uri="{BB962C8B-B14F-4D97-AF65-F5344CB8AC3E}">
        <p14:creationId xmlns:p14="http://schemas.microsoft.com/office/powerpoint/2010/main" val="3723648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760</TotalTime>
  <Words>433</Words>
  <Application>Microsoft Office PowerPoint</Application>
  <PresentationFormat>Custom</PresentationFormat>
  <Paragraphs>69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berto Casartelli</dc:creator>
  <cp:lastModifiedBy>Balindan, Danica Joy</cp:lastModifiedBy>
  <cp:revision>88</cp:revision>
  <dcterms:created xsi:type="dcterms:W3CDTF">2016-08-14T10:18:44Z</dcterms:created>
  <dcterms:modified xsi:type="dcterms:W3CDTF">2017-11-28T21:42:12Z</dcterms:modified>
</cp:coreProperties>
</file>